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9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9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633372"/>
            <a:ext cx="712879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lzaid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3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5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Obesity-driven adipocyte–immune cell miscommunication triggers inflammation, causing impaired insulin sensitivity and beta cell dysfunction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7F7F15B-EEE7-D9A1-6206-1FC1BB6B0F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4815" y="1110203"/>
            <a:ext cx="4454371" cy="49110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/>
              <a:t>Mechanistic links between obesity and autoimmunity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F43451E-0276-E9E4-F0E0-F1F7CC4D59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9816" y="843001"/>
            <a:ext cx="7884368" cy="453021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8E0FDE6-7FD0-2772-3317-1015A570FDCC}"/>
              </a:ext>
            </a:extLst>
          </p:cNvPr>
          <p:cNvSpPr txBox="1"/>
          <p:nvPr/>
        </p:nvSpPr>
        <p:spPr>
          <a:xfrm>
            <a:off x="107504" y="5633372"/>
            <a:ext cx="712879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lzaid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3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5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Obesity and management challenges in type 1 diabet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F5DFB7C-CD70-265F-2847-B75277676B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544" y="1315201"/>
            <a:ext cx="8208912" cy="379527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5800AB-8E4F-4247-6B7A-27B40C072629}"/>
              </a:ext>
            </a:extLst>
          </p:cNvPr>
          <p:cNvSpPr txBox="1"/>
          <p:nvPr/>
        </p:nvSpPr>
        <p:spPr>
          <a:xfrm>
            <a:off x="107504" y="5633372"/>
            <a:ext cx="712879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lzaid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3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5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On-screen Show (4:3)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9</cp:revision>
  <dcterms:created xsi:type="dcterms:W3CDTF">2016-06-15T12:53:43Z</dcterms:created>
  <dcterms:modified xsi:type="dcterms:W3CDTF">2025-04-29T14:31:12Z</dcterms:modified>
</cp:coreProperties>
</file>